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66760" y="1240920"/>
            <a:ext cx="4464000" cy="3349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86B1D4-5ECB-415D-A593-084EFD8F33B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ldImg"/>
          </p:nvPr>
        </p:nvSpPr>
        <p:spPr>
          <a:xfrm>
            <a:off x="1166760" y="1241280"/>
            <a:ext cx="4464000" cy="3349800"/>
          </a:xfrm>
          <a:prstGeom prst="rect">
            <a:avLst/>
          </a:prstGeom>
          <a:ln w="0">
            <a:noFill/>
          </a:ln>
        </p:spPr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スライド番号プレースホルダー 3"/>
          <p:cNvSpPr/>
          <p:nvPr/>
        </p:nvSpPr>
        <p:spPr>
          <a:xfrm>
            <a:off x="3849840" y="9428040"/>
            <a:ext cx="29462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C539F7-36D9-4DE3-876F-8BA9A7410B8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DE1E5-6E11-4E9E-B494-3A7BB42B52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74D59-81F5-4370-A51D-E8B2293B40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D6F12-B304-4345-9BB7-EEBF146BDF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21B25-54F5-4F1E-8EB2-FAF04F747A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C1495A-A0CE-4501-A2EA-DB16A09C76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EF420-343D-4D21-B9B5-9D0B1B29C3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8D892-E3EB-43E4-91FF-E56E5FBF38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BA020-CB34-49CC-9004-79C1167576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B62CE-F405-467F-A908-E582F51BD9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216E3-7BD7-4E4F-BEBF-822811F731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D6F9C-1BBD-49D8-9B8A-18686DD37F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6D03D-6785-40F3-9C13-B09E46E6ED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033E14-4F63-47CD-BE31-6F2126DAC5E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1" descr=""/>
          <p:cNvPicPr/>
          <p:nvPr/>
        </p:nvPicPr>
        <p:blipFill>
          <a:blip r:embed="rId1"/>
          <a:stretch/>
        </p:blipFill>
        <p:spPr>
          <a:xfrm>
            <a:off x="1679400" y="65160"/>
            <a:ext cx="5859720" cy="578484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10"/>
          <p:cNvSpPr/>
          <p:nvPr/>
        </p:nvSpPr>
        <p:spPr>
          <a:xfrm>
            <a:off x="2282760" y="549360"/>
            <a:ext cx="117000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Hb (g/dL)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1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25"/>
          <p:cNvSpPr/>
          <p:nvPr/>
        </p:nvSpPr>
        <p:spPr>
          <a:xfrm>
            <a:off x="3524400" y="1893960"/>
            <a:ext cx="120168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ST (IU/L)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26"/>
          <p:cNvSpPr/>
          <p:nvPr/>
        </p:nvSpPr>
        <p:spPr>
          <a:xfrm>
            <a:off x="4840200" y="3208320"/>
            <a:ext cx="120024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LT (IU/L)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27"/>
          <p:cNvSpPr/>
          <p:nvPr/>
        </p:nvSpPr>
        <p:spPr>
          <a:xfrm>
            <a:off x="6137280" y="4525920"/>
            <a:ext cx="123516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Times New Roman"/>
              </a:rPr>
              <a:t>γ-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GTP (IU/L) 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t POD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正方形/長方形 12"/>
          <p:cNvSpPr/>
          <p:nvPr/>
        </p:nvSpPr>
        <p:spPr>
          <a:xfrm>
            <a:off x="3952080" y="210960"/>
            <a:ext cx="785880" cy="596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r = - 0.13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 = 0.121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正方形/長方形 31"/>
          <p:cNvSpPr/>
          <p:nvPr/>
        </p:nvSpPr>
        <p:spPr>
          <a:xfrm>
            <a:off x="5286960" y="21096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r = 0.02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 = 0.806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正方形/長方形 32"/>
          <p:cNvSpPr/>
          <p:nvPr/>
        </p:nvSpPr>
        <p:spPr>
          <a:xfrm>
            <a:off x="6585840" y="21096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r = - 0.07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p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メイリオ"/>
              </a:rPr>
              <a:t> = 0.400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正方形/長方形 33"/>
          <p:cNvSpPr/>
          <p:nvPr/>
        </p:nvSpPr>
        <p:spPr>
          <a:xfrm>
            <a:off x="4961520" y="168120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r = 0.75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p</a:t>
            </a: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 &lt; 0.0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正方形/長方形 34"/>
          <p:cNvSpPr/>
          <p:nvPr/>
        </p:nvSpPr>
        <p:spPr>
          <a:xfrm>
            <a:off x="6585840" y="2994120"/>
            <a:ext cx="7858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r = 0.42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p</a:t>
            </a: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 &lt; 0.0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正方形/長方形 35"/>
          <p:cNvSpPr/>
          <p:nvPr/>
        </p:nvSpPr>
        <p:spPr>
          <a:xfrm>
            <a:off x="6560280" y="1611360"/>
            <a:ext cx="715680" cy="428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r = 0.25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p</a:t>
            </a:r>
            <a:r>
              <a:rPr b="1" lang="en-US" sz="1100" spc="-1" strike="noStrike">
                <a:solidFill>
                  <a:srgbClr val="ff0000"/>
                </a:solidFill>
                <a:latin typeface="Times New Roman"/>
                <a:ea typeface="メイリオ"/>
              </a:rPr>
              <a:t> &lt; 0.00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3"/>
          <p:cNvSpPr/>
          <p:nvPr/>
        </p:nvSpPr>
        <p:spPr>
          <a:xfrm>
            <a:off x="-17640" y="5559480"/>
            <a:ext cx="9161640" cy="12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</a:t>
            </a: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5 Correlation between liver function test value at post-operative day (POD) 7 and hemoglobin at POD1</a:t>
            </a:r>
            <a:br>
              <a:rPr sz="1400"/>
            </a:b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nificant correlation was not observed between hemoglobin level POD1 and liver function tests POD7, such as aspartate aminotransferase, alanine aminotransferase and gamma-glutamyl transferase. Statistical analysis were performed using Pearson correlation coefficient. The red ellipse represents 95% confidence interv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10T02:56:22Z</dcterms:created>
  <dc:creator>近藤悠希【Yuki KONDO】</dc:creator>
  <dc:description/>
  <dc:language>en-US</dc:language>
  <cp:lastModifiedBy>近藤悠希【Yuki KONDO】</cp:lastModifiedBy>
  <cp:lastPrinted>2016-08-08T11:36:20Z</cp:lastPrinted>
  <dcterms:modified xsi:type="dcterms:W3CDTF">2017-01-13T11:43:31Z</dcterms:modified>
  <cp:revision>62</cp:revision>
  <dc:subject/>
  <dc:title>PowerPoint プレゼンテーション</dc:title>
</cp:coreProperties>
</file>